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30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663"/>
  </p:normalViewPr>
  <p:slideViewPr>
    <p:cSldViewPr snapToGrid="0" snapToObjects="1" showGuides="1">
      <p:cViewPr>
        <p:scale>
          <a:sx n="126" d="100"/>
          <a:sy n="126" d="100"/>
        </p:scale>
        <p:origin x="2048" y="14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B8117A-CA55-F148-92C4-755D0E897D94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41C2F-C52E-D043-A026-2E89E5440C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38512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B8117A-CA55-F148-92C4-755D0E897D94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41C2F-C52E-D043-A026-2E89E5440C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83854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B8117A-CA55-F148-92C4-755D0E897D94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41C2F-C52E-D043-A026-2E89E5440C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48013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B8117A-CA55-F148-92C4-755D0E897D94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41C2F-C52E-D043-A026-2E89E5440C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16664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B8117A-CA55-F148-92C4-755D0E897D94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41C2F-C52E-D043-A026-2E89E5440C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38592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B8117A-CA55-F148-92C4-755D0E897D94}" type="datetimeFigureOut">
              <a:rPr lang="en-US" smtClean="0"/>
              <a:t>5/27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41C2F-C52E-D043-A026-2E89E5440C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7425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B8117A-CA55-F148-92C4-755D0E897D94}" type="datetimeFigureOut">
              <a:rPr lang="en-US" smtClean="0"/>
              <a:t>5/27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41C2F-C52E-D043-A026-2E89E5440C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9720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B8117A-CA55-F148-92C4-755D0E897D94}" type="datetimeFigureOut">
              <a:rPr lang="en-US" smtClean="0"/>
              <a:t>5/27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41C2F-C52E-D043-A026-2E89E5440C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90042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B8117A-CA55-F148-92C4-755D0E897D94}" type="datetimeFigureOut">
              <a:rPr lang="en-US" smtClean="0"/>
              <a:t>5/27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41C2F-C52E-D043-A026-2E89E5440C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70841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B8117A-CA55-F148-92C4-755D0E897D94}" type="datetimeFigureOut">
              <a:rPr lang="en-US" smtClean="0"/>
              <a:t>5/27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41C2F-C52E-D043-A026-2E89E5440C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8321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B8117A-CA55-F148-92C4-755D0E897D94}" type="datetimeFigureOut">
              <a:rPr lang="en-US" smtClean="0"/>
              <a:t>5/27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41C2F-C52E-D043-A026-2E89E5440C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84977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B8117A-CA55-F148-92C4-755D0E897D94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641C2F-C52E-D043-A026-2E89E5440C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43095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BCA2BE33-4729-644D-846E-9B6B8B7F0ED6}"/>
              </a:ext>
            </a:extLst>
          </p:cNvPr>
          <p:cNvGraphicFramePr>
            <a:graphicFrameLocks noGrp="1"/>
          </p:cNvGraphicFramePr>
          <p:nvPr/>
        </p:nvGraphicFramePr>
        <p:xfrm>
          <a:off x="210964" y="461665"/>
          <a:ext cx="6436074" cy="9026696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110777">
                  <a:extLst>
                    <a:ext uri="{9D8B030D-6E8A-4147-A177-3AD203B41FA5}">
                      <a16:colId xmlns:a16="http://schemas.microsoft.com/office/drawing/2014/main" val="127418659"/>
                    </a:ext>
                  </a:extLst>
                </a:gridCol>
                <a:gridCol w="3529230">
                  <a:extLst>
                    <a:ext uri="{9D8B030D-6E8A-4147-A177-3AD203B41FA5}">
                      <a16:colId xmlns:a16="http://schemas.microsoft.com/office/drawing/2014/main" val="1536428111"/>
                    </a:ext>
                  </a:extLst>
                </a:gridCol>
                <a:gridCol w="1796067">
                  <a:extLst>
                    <a:ext uri="{9D8B030D-6E8A-4147-A177-3AD203B41FA5}">
                      <a16:colId xmlns:a16="http://schemas.microsoft.com/office/drawing/2014/main" val="2234267778"/>
                    </a:ext>
                  </a:extLst>
                </a:gridCol>
              </a:tblGrid>
              <a:tr h="16119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er name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quence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rpose of use</a:t>
                      </a:r>
                      <a:endParaRPr lang="en-IN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34992963"/>
                  </a:ext>
                </a:extLst>
              </a:tr>
              <a:tr h="161191">
                <a:tc gridSpan="3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struction and confirmation of sch9/sch9 mutants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5602781"/>
                  </a:ext>
                </a:extLst>
              </a:tr>
              <a:tr h="32238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KG1</a:t>
                      </a: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GCGGTACCGTTGGTACCTTCTACAGATGC</a:t>
                      </a: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plification and cloning of upstream homology region of SCH9 ORF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55472142"/>
                  </a:ext>
                </a:extLst>
              </a:tr>
              <a:tr h="32238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G2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TCCTCGAGAATGGGTGAGCAGATGATGG 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IN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/>
                </a:tc>
                <a:extLst>
                  <a:ext uri="{0D108BD9-81ED-4DB2-BD59-A6C34878D82A}">
                    <a16:rowId xmlns:a16="http://schemas.microsoft.com/office/drawing/2014/main" val="1312764018"/>
                  </a:ext>
                </a:extLst>
              </a:tr>
              <a:tr h="32238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G3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GCCCGCGGGATGAAGAAATGCAACCAGCAG 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plification and cloning of downstream homology region of SCH9 ORF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95584531"/>
                  </a:ext>
                </a:extLst>
              </a:tr>
              <a:tr h="48357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G4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GAGAGCTCCAAAATTGGAATCGTTAGAAACGG 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IN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/>
                </a:tc>
                <a:extLst>
                  <a:ext uri="{0D108BD9-81ED-4DB2-BD59-A6C34878D82A}">
                    <a16:rowId xmlns:a16="http://schemas.microsoft.com/office/drawing/2014/main" val="2311267625"/>
                  </a:ext>
                </a:extLst>
              </a:tr>
              <a:tr h="32238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G5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ACAATTTAACTTAACATGTGGCAC 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4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R confirmation of Sch9::CaSAT1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19775382"/>
                  </a:ext>
                </a:extLst>
              </a:tr>
              <a:tr h="32238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G6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CTGAAACTTGAAGGATTAGATAC 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IN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/>
                </a:tc>
                <a:extLst>
                  <a:ext uri="{0D108BD9-81ED-4DB2-BD59-A6C34878D82A}">
                    <a16:rowId xmlns:a16="http://schemas.microsoft.com/office/drawing/2014/main" val="4132017210"/>
                  </a:ext>
                </a:extLst>
              </a:tr>
              <a:tr h="16119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G7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GTGGCTACAACTCAGAGCACGC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IN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/>
                </a:tc>
                <a:extLst>
                  <a:ext uri="{0D108BD9-81ED-4DB2-BD59-A6C34878D82A}">
                    <a16:rowId xmlns:a16="http://schemas.microsoft.com/office/drawing/2014/main" val="830100817"/>
                  </a:ext>
                </a:extLst>
              </a:tr>
              <a:tr h="16119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G8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AGAGACACAAACGAACAATGTACC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IN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/>
                </a:tc>
                <a:extLst>
                  <a:ext uri="{0D108BD9-81ED-4DB2-BD59-A6C34878D82A}">
                    <a16:rowId xmlns:a16="http://schemas.microsoft.com/office/drawing/2014/main" val="3096144783"/>
                  </a:ext>
                </a:extLst>
              </a:tr>
              <a:tr h="161191">
                <a:tc gridSpan="3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struction and confirmation of URA3 integrated reporter strain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38654884"/>
                  </a:ext>
                </a:extLst>
              </a:tr>
              <a:tr h="16119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KG9</a:t>
                      </a: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TCGGGCCCGGGGAACACCAACTTCAAAA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plification and cloning of upstream homology region of Chr5-497kb locus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50650020"/>
                  </a:ext>
                </a:extLst>
              </a:tr>
              <a:tr h="48357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KG10</a:t>
                      </a: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TCCTCGAGGAGAGTCATGACACACCACTTGTTG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IN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/>
                </a:tc>
                <a:extLst>
                  <a:ext uri="{0D108BD9-81ED-4DB2-BD59-A6C34878D82A}">
                    <a16:rowId xmlns:a16="http://schemas.microsoft.com/office/drawing/2014/main" val="826472284"/>
                  </a:ext>
                </a:extLst>
              </a:tr>
              <a:tr h="32238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KG11</a:t>
                      </a: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CGCTGCAGGACTGGAACCTTATGTGAGGAGACAG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plification and cloning of downstream homology region of Chr5-497_kb locus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47924051"/>
                  </a:ext>
                </a:extLst>
              </a:tr>
              <a:tr h="32238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KG12</a:t>
                      </a: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CTGGATCCGACATCATGGATGAGCCTTGGTAG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IN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/>
                </a:tc>
                <a:extLst>
                  <a:ext uri="{0D108BD9-81ED-4DB2-BD59-A6C34878D82A}">
                    <a16:rowId xmlns:a16="http://schemas.microsoft.com/office/drawing/2014/main" val="659593088"/>
                  </a:ext>
                </a:extLst>
              </a:tr>
              <a:tr h="16119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KG13</a:t>
                      </a: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GAAAAAGAAAGAGAAGGATTCTAAGG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R confirmation of Chr5-497_kb::URA3 transformants 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55842269"/>
                  </a:ext>
                </a:extLst>
              </a:tr>
              <a:tr h="32238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G14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CCTTCTTCTTGGCCACCC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IN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/>
                </a:tc>
                <a:extLst>
                  <a:ext uri="{0D108BD9-81ED-4DB2-BD59-A6C34878D82A}">
                    <a16:rowId xmlns:a16="http://schemas.microsoft.com/office/drawing/2014/main" val="4152144451"/>
                  </a:ext>
                </a:extLst>
              </a:tr>
              <a:tr h="32238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KG15</a:t>
                      </a: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ACTGGGAGGGTGCATTGG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be for Southern hybridization confirmation of the sch9/sch9 mutants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04101076"/>
                  </a:ext>
                </a:extLst>
              </a:tr>
              <a:tr h="32238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KG16</a:t>
                      </a: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ATGTGGGCGTGTGATTGCGC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IN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/>
                </a:tc>
                <a:extLst>
                  <a:ext uri="{0D108BD9-81ED-4DB2-BD59-A6C34878D82A}">
                    <a16:rowId xmlns:a16="http://schemas.microsoft.com/office/drawing/2014/main" val="1858129948"/>
                  </a:ext>
                </a:extLst>
              </a:tr>
              <a:tr h="16119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G17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TTTGGTATGAAAAGAGGAACTCTAAC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plification of MTLa locus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41273878"/>
                  </a:ext>
                </a:extLst>
              </a:tr>
              <a:tr h="16119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G18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ACTAATTTTGAAACCATTTGGAGTCT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IN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/>
                </a:tc>
                <a:extLst>
                  <a:ext uri="{0D108BD9-81ED-4DB2-BD59-A6C34878D82A}">
                    <a16:rowId xmlns:a16="http://schemas.microsoft.com/office/drawing/2014/main" val="1311211105"/>
                  </a:ext>
                </a:extLst>
              </a:tr>
              <a:tr h="16119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G19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AAACATTAAGCATAGAGGACAAAGAA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plification of the </a:t>
                      </a:r>
                      <a:r>
                        <a:rPr lang="en-IN" sz="1000" b="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TLalpha</a:t>
                      </a: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locus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47422815"/>
                  </a:ext>
                </a:extLst>
              </a:tr>
              <a:tr h="16119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G20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CTTCAAATGCAAAATGTAAAACATAC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IN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/>
                </a:tc>
                <a:extLst>
                  <a:ext uri="{0D108BD9-81ED-4DB2-BD59-A6C34878D82A}">
                    <a16:rowId xmlns:a16="http://schemas.microsoft.com/office/drawing/2014/main" val="2429717626"/>
                  </a:ext>
                </a:extLst>
              </a:tr>
              <a:tr h="161191">
                <a:tc gridSpan="3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bes for Southern hybridization experiments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59770525"/>
                  </a:ext>
                </a:extLst>
              </a:tr>
              <a:tr h="16119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G21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TATTGAAGAACCTAGAGGG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ig14_Probe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15658338"/>
                  </a:ext>
                </a:extLst>
              </a:tr>
              <a:tr h="16119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G22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CTTGTAATTCAGGTGACA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IN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/>
                </a:tc>
                <a:extLst>
                  <a:ext uri="{0D108BD9-81ED-4DB2-BD59-A6C34878D82A}">
                    <a16:rowId xmlns:a16="http://schemas.microsoft.com/office/drawing/2014/main" val="966219612"/>
                  </a:ext>
                </a:extLst>
              </a:tr>
              <a:tr h="16119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G23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ACTCCACAGAAACAATCTCC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ig16_Probe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85123939"/>
                  </a:ext>
                </a:extLst>
              </a:tr>
              <a:tr h="16119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G24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GGGATACACTTCTTATGACC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IN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/>
                </a:tc>
                <a:extLst>
                  <a:ext uri="{0D108BD9-81ED-4DB2-BD59-A6C34878D82A}">
                    <a16:rowId xmlns:a16="http://schemas.microsoft.com/office/drawing/2014/main" val="2793834105"/>
                  </a:ext>
                </a:extLst>
              </a:tr>
              <a:tr h="16119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G25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CAGTTGAAATCTCTTGGACC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be A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71165428"/>
                  </a:ext>
                </a:extLst>
              </a:tr>
              <a:tr h="16119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G26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ATGTTGCGATCACTTTGG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IN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/>
                </a:tc>
                <a:extLst>
                  <a:ext uri="{0D108BD9-81ED-4DB2-BD59-A6C34878D82A}">
                    <a16:rowId xmlns:a16="http://schemas.microsoft.com/office/drawing/2014/main" val="1397502348"/>
                  </a:ext>
                </a:extLst>
              </a:tr>
              <a:tr h="16119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G27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AAAGATTCAGGATAAACCAATTG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be B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33225339"/>
                  </a:ext>
                </a:extLst>
              </a:tr>
              <a:tr h="16119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G28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ATTTGACTTGCCCACTC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IN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/>
                </a:tc>
                <a:extLst>
                  <a:ext uri="{0D108BD9-81ED-4DB2-BD59-A6C34878D82A}">
                    <a16:rowId xmlns:a16="http://schemas.microsoft.com/office/drawing/2014/main" val="1913449350"/>
                  </a:ext>
                </a:extLst>
              </a:tr>
              <a:tr h="32238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G29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CATGAGAATACAAAGAGAAAGTT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be C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88195001"/>
                  </a:ext>
                </a:extLst>
              </a:tr>
              <a:tr h="32238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G30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CTTTTGTAGTCTATCCAACTCTG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IN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/>
                </a:tc>
                <a:extLst>
                  <a:ext uri="{0D108BD9-81ED-4DB2-BD59-A6C34878D82A}">
                    <a16:rowId xmlns:a16="http://schemas.microsoft.com/office/drawing/2014/main" val="1094541679"/>
                  </a:ext>
                </a:extLst>
              </a:tr>
              <a:tr h="16119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G31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GCATACGTCACAGTTTGG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be D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18910430"/>
                  </a:ext>
                </a:extLst>
              </a:tr>
              <a:tr h="16119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G32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TGCTATCATCTCAAACCAAGG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IN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/>
                </a:tc>
                <a:extLst>
                  <a:ext uri="{0D108BD9-81ED-4DB2-BD59-A6C34878D82A}">
                    <a16:rowId xmlns:a16="http://schemas.microsoft.com/office/drawing/2014/main" val="2685750881"/>
                  </a:ext>
                </a:extLst>
              </a:tr>
              <a:tr h="16119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G33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TGGTTACGGTACCAGATTG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be E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73551260"/>
                  </a:ext>
                </a:extLst>
              </a:tr>
              <a:tr h="16119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G34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GGCATTGATTCTGTTACC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IN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/>
                </a:tc>
                <a:extLst>
                  <a:ext uri="{0D108BD9-81ED-4DB2-BD59-A6C34878D82A}">
                    <a16:rowId xmlns:a16="http://schemas.microsoft.com/office/drawing/2014/main" val="3049812541"/>
                  </a:ext>
                </a:extLst>
              </a:tr>
              <a:tr h="161191"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G35</a:t>
                      </a: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TGTTATCCAGTGTACCAGTTG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be F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11977394"/>
                  </a:ext>
                </a:extLst>
              </a:tr>
              <a:tr h="161191"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G36</a:t>
                      </a: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IN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GATTTCTGGTGGTTCAAC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en-IN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6415" marR="36415" marT="0" marB="0" anchor="ctr"/>
                </a:tc>
                <a:extLst>
                  <a:ext uri="{0D108BD9-81ED-4DB2-BD59-A6C34878D82A}">
                    <a16:rowId xmlns:a16="http://schemas.microsoft.com/office/drawing/2014/main" val="1117829628"/>
                  </a:ext>
                </a:extLst>
              </a:tr>
            </a:tbl>
          </a:graphicData>
        </a:graphic>
      </p:graphicFrame>
      <p:sp>
        <p:nvSpPr>
          <p:cNvPr id="5" name="Rectangle 1">
            <a:extLst>
              <a:ext uri="{FF2B5EF4-FFF2-40B4-BE49-F238E27FC236}">
                <a16:creationId xmlns:a16="http://schemas.microsoft.com/office/drawing/2014/main" id="{7DC8536C-4976-ED49-B795-23E75D8778F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0962" y="107721"/>
            <a:ext cx="3239990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ry file 9: List of primers used in this study</a:t>
            </a: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745374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07</Words>
  <Application>Microsoft Macintosh PowerPoint</Application>
  <PresentationFormat>A4 Paper (210x297 mm)</PresentationFormat>
  <Paragraphs>9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rishnendu guin</dc:creator>
  <cp:lastModifiedBy>krishnendu guin</cp:lastModifiedBy>
  <cp:revision>1</cp:revision>
  <dcterms:created xsi:type="dcterms:W3CDTF">2020-05-27T11:08:25Z</dcterms:created>
  <dcterms:modified xsi:type="dcterms:W3CDTF">2020-05-27T11:09:15Z</dcterms:modified>
</cp:coreProperties>
</file>